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9" r:id="rId1"/>
  </p:sldMasterIdLst>
  <p:notesMasterIdLst>
    <p:notesMasterId r:id="rId3"/>
  </p:notesMasterIdLst>
  <p:sldIdLst>
    <p:sldId id="39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ther Drees" initials="ED" lastIdx="17" clrIdx="0">
    <p:extLst>
      <p:ext uri="{19B8F6BF-5375-455C-9EA6-DF929625EA0E}">
        <p15:presenceInfo xmlns:p15="http://schemas.microsoft.com/office/powerpoint/2012/main" userId="4b13d3f0a7644037" providerId="Windows Live"/>
      </p:ext>
    </p:extLst>
  </p:cmAuthor>
  <p:cmAuthor id="2" name="Microsoft Office User" initials="MOU" lastIdx="3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3" name="Michiel Pegtel" initials="MOU" lastIdx="1" clrIdx="2">
    <p:extLst>
      <p:ext uri="{19B8F6BF-5375-455C-9EA6-DF929625EA0E}">
        <p15:presenceInfo xmlns:p15="http://schemas.microsoft.com/office/powerpoint/2012/main" userId="Michiel Pegtel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80"/>
    <a:srgbClr val="33CCCC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Stijl, gemiddeld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CAF9ED-07DC-4A11-8D7F-57B35C25682E}" styleName="Stijl, gemiddeld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793D81CF-94F2-401A-BA57-92F5A7B2D0C5}" styleName="Stijl, gemiddeld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B301B821-A1FF-4177-AEE7-76D212191A09}" styleName="Stijl, gemiddeld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8A107856-5554-42FB-B03E-39F5DBC370BA}" styleName="Stijl, gemiddeld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32" autoAdjust="0"/>
    <p:restoredTop sz="94747" autoAdjust="0"/>
  </p:normalViewPr>
  <p:slideViewPr>
    <p:cSldViewPr snapToGrid="0">
      <p:cViewPr varScale="1">
        <p:scale>
          <a:sx n="70" d="100"/>
          <a:sy n="70" d="100"/>
        </p:scale>
        <p:origin x="102" y="6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1475D1-9488-4BF9-A372-AC9EB7DE42D7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E42423-5928-4029-928F-E7A38F026CFA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192853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0B573B-673F-D83B-C365-74F158D966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3B121ED0-D4EE-EE02-F6CF-EE17964D8D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nl-NL"/>
              <a:t>Klikken om de ondertitelstijl van het model te bewerken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C1622C1-5CA4-6571-2AB0-31182FA29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9B7F234-E10A-E4CC-A503-F2A22B068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D8CDA7C6-6655-D74A-9EDA-8E74A78D85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09411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C2E9869-E118-7CED-EDE9-B8416A14A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7BC51E09-7E6D-6F6E-24B1-CD41C778DA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1B124198-59EF-ECB6-FFD5-90B548FCF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8CAB09EF-D23A-268F-CD83-6D96653D1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D2A03A18-14B9-68EB-FCC1-4ECC1AC6F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58328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171D75B0-AD3D-E099-B91D-9944E6CE66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9083DD84-4A1A-53A2-41B0-CB7EB05989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AD156DF5-F60C-FE11-1FE0-A0522B1348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ED490D8-9D3E-747C-3033-D0F25B7CF1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8F11942-7BE2-373A-9C0A-A00F2369D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84938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A7B2FB-65CF-19B4-644C-13C200D157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596073C-4C6B-52F3-3187-9AFB0480FF4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5B85A6D6-CA9C-FA9C-D15F-E82BD2365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6589993-96BF-404E-EFC0-875589A65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1051699-098F-4452-CE8F-7FAA86E18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691531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A2BDCA4-EA70-1FB3-B178-F2D7200CD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CB19BF1B-B621-C2D9-4362-9F2FAD33E0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896C6DDD-B19A-3FC1-1259-63AFAA9B2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A2587A1-0EF2-489A-502D-5EB83C576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C07E7712-CAA3-011C-D8F0-AE32A2A81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00688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9F0FD84-63A9-8F7C-6567-E1D02728A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749D03A3-E51D-79E9-53AD-41A51E0D78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113CB6A1-D362-A1EF-0EEC-17AAD0BD6C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74F75EE4-1EBA-F37A-8519-8A81AE881E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4C6169ED-2FCB-55A5-DBDF-345865442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2ABABEB-08CA-6288-13ED-5BB9FB6FF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05130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231622-1B78-75AD-B99E-ACBC07D5D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139E72D5-BEC3-9961-97FF-6296F11B1E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095460E-1335-B6A0-F932-87E9BA0B82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35BC89A9-2C6F-B25E-E65B-CF1C485E51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8CE0BC08-22F9-D4C9-A0B6-9F26D3C643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1A28548B-F950-77A4-510F-4A185B7E7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2C591B1E-CA16-EF80-E029-20E9EA3E38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B467FE5E-A6EF-1FF6-170C-4DBA21923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5061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62D5A0-0CF5-9EF2-B3CA-DA823FB80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372656EF-1770-98F4-72D7-32A2F1FD9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6F0642CF-0976-9EA1-0E96-C8235FD6C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F62AFBE9-00D0-0892-7A18-609FEA7EB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69686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0BCE8D04-A359-E3A3-15A8-C8D32054D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39E5778D-022F-AFAC-341E-8CACED34F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D9D0F03F-5141-367A-222D-955115A5F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690066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F134AF7-6CBF-AA52-CBD5-A55074F97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4C041FA-D2F0-3489-E0B5-297413A418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1A61CA1C-7228-22EB-F7A6-202EA9EE9E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C3211EBC-181F-F6A8-60F5-6A5050D7FB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1FD74531-2CD5-1728-04DC-969D704D0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4C96567-F4C1-262E-FDED-EC23427F2C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27363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5EF7D01-F992-B597-8E66-608BA773FC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91E3D905-7DD7-728D-AFC1-13E424F58A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83A8B209-D769-C88B-3163-58718B5B1E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0095F0D2-8E65-4CA6-8941-B13A635C3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F5DFDBB-F97D-2812-08B1-E710F124C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FA81E60-68DC-73A9-FEC1-681B5EFB68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68108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B59FB189-E90D-5466-5AE9-BCFC4AEF26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US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EDD60C63-525B-CF01-077C-CC2511213E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B8C1729C-6912-87AF-CD93-0D85CB0BC7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5F8454-91F7-4C11-AAC7-607F59F82132}" type="datetimeFigureOut">
              <a:rPr lang="nl-NL" smtClean="0"/>
              <a:t>7-6-2024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931F0D1-F28E-F7E5-F6DF-B5D7989428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521CFAFE-F9D5-D7F7-1BE2-53DDAED0B5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1A95A-E4B4-4009-8B8E-C99DBEAC760E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8370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>
            <a:extLst>
              <a:ext uri="{FF2B5EF4-FFF2-40B4-BE49-F238E27FC236}">
                <a16:creationId xmlns:a16="http://schemas.microsoft.com/office/drawing/2014/main" id="{2FAF9430-CC0E-495E-A87D-B9A3F6075333}"/>
              </a:ext>
            </a:extLst>
          </p:cNvPr>
          <p:cNvSpPr txBox="1">
            <a:spLocks/>
          </p:cNvSpPr>
          <p:nvPr/>
        </p:nvSpPr>
        <p:spPr>
          <a:xfrm>
            <a:off x="337473" y="364998"/>
            <a:ext cx="8253153" cy="31591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nl-NL" sz="1800" b="1" dirty="0" err="1">
                <a:latin typeface="+mn-lt"/>
              </a:rPr>
              <a:t>Suppl</a:t>
            </a:r>
            <a:r>
              <a:rPr lang="nl-NL" sz="1800" b="1" dirty="0">
                <a:latin typeface="+mn-lt"/>
              </a:rPr>
              <a:t>. Figure 1: </a:t>
            </a:r>
            <a:r>
              <a:rPr lang="en-US" sz="1800" b="1" dirty="0">
                <a:latin typeface="+mn-lt"/>
              </a:rPr>
              <a:t>Quality-controlled EV-miRNA assay analyzed with GLMM with bootstrapping with Cq-values</a:t>
            </a:r>
          </a:p>
        </p:txBody>
      </p:sp>
      <p:sp>
        <p:nvSpPr>
          <p:cNvPr id="7" name="Rectangle 1">
            <a:extLst>
              <a:ext uri="{FF2B5EF4-FFF2-40B4-BE49-F238E27FC236}">
                <a16:creationId xmlns:a16="http://schemas.microsoft.com/office/drawing/2014/main" id="{6DDD3F21-2DAD-0331-5CE1-BAA53CC459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-1523999" y="-184665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2" name="Tabel 11">
            <a:extLst>
              <a:ext uri="{FF2B5EF4-FFF2-40B4-BE49-F238E27FC236}">
                <a16:creationId xmlns:a16="http://schemas.microsoft.com/office/drawing/2014/main" id="{B5FAA923-C161-0197-2904-6A7E758D38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7576181"/>
              </p:ext>
            </p:extLst>
          </p:nvPr>
        </p:nvGraphicFramePr>
        <p:xfrm>
          <a:off x="369742" y="4563332"/>
          <a:ext cx="7314426" cy="1070610"/>
        </p:xfrm>
        <a:graphic>
          <a:graphicData uri="http://schemas.openxmlformats.org/drawingml/2006/table">
            <a:tbl>
              <a:tblPr>
                <a:tableStyleId>{21E4AEA4-8DFA-4A89-87EB-49C32662AFE0}</a:tableStyleId>
              </a:tblPr>
              <a:tblGrid>
                <a:gridCol w="1359708">
                  <a:extLst>
                    <a:ext uri="{9D8B030D-6E8A-4147-A177-3AD203B41FA5}">
                      <a16:colId xmlns:a16="http://schemas.microsoft.com/office/drawing/2014/main" val="2801629662"/>
                    </a:ext>
                  </a:extLst>
                </a:gridCol>
                <a:gridCol w="1173345">
                  <a:extLst>
                    <a:ext uri="{9D8B030D-6E8A-4147-A177-3AD203B41FA5}">
                      <a16:colId xmlns:a16="http://schemas.microsoft.com/office/drawing/2014/main" val="228268988"/>
                    </a:ext>
                  </a:extLst>
                </a:gridCol>
                <a:gridCol w="789101">
                  <a:extLst>
                    <a:ext uri="{9D8B030D-6E8A-4147-A177-3AD203B41FA5}">
                      <a16:colId xmlns:a16="http://schemas.microsoft.com/office/drawing/2014/main" val="876226552"/>
                    </a:ext>
                  </a:extLst>
                </a:gridCol>
                <a:gridCol w="1250092">
                  <a:extLst>
                    <a:ext uri="{9D8B030D-6E8A-4147-A177-3AD203B41FA5}">
                      <a16:colId xmlns:a16="http://schemas.microsoft.com/office/drawing/2014/main" val="2555303864"/>
                    </a:ext>
                  </a:extLst>
                </a:gridCol>
                <a:gridCol w="480637">
                  <a:extLst>
                    <a:ext uri="{9D8B030D-6E8A-4147-A177-3AD203B41FA5}">
                      <a16:colId xmlns:a16="http://schemas.microsoft.com/office/drawing/2014/main" val="1637900664"/>
                    </a:ext>
                  </a:extLst>
                </a:gridCol>
                <a:gridCol w="481267">
                  <a:extLst>
                    <a:ext uri="{9D8B030D-6E8A-4147-A177-3AD203B41FA5}">
                      <a16:colId xmlns:a16="http://schemas.microsoft.com/office/drawing/2014/main" val="1042327056"/>
                    </a:ext>
                  </a:extLst>
                </a:gridCol>
                <a:gridCol w="461066">
                  <a:extLst>
                    <a:ext uri="{9D8B030D-6E8A-4147-A177-3AD203B41FA5}">
                      <a16:colId xmlns:a16="http://schemas.microsoft.com/office/drawing/2014/main" val="3838182025"/>
                    </a:ext>
                  </a:extLst>
                </a:gridCol>
                <a:gridCol w="501150">
                  <a:extLst>
                    <a:ext uri="{9D8B030D-6E8A-4147-A177-3AD203B41FA5}">
                      <a16:colId xmlns:a16="http://schemas.microsoft.com/office/drawing/2014/main" val="334127104"/>
                    </a:ext>
                  </a:extLst>
                </a:gridCol>
                <a:gridCol w="818060">
                  <a:extLst>
                    <a:ext uri="{9D8B030D-6E8A-4147-A177-3AD203B41FA5}">
                      <a16:colId xmlns:a16="http://schemas.microsoft.com/office/drawing/2014/main" val="2554768462"/>
                    </a:ext>
                  </a:extLst>
                </a:gridCol>
              </a:tblGrid>
              <a:tr h="330224">
                <a:tc>
                  <a:txBody>
                    <a:bodyPr/>
                    <a:lstStyle/>
                    <a:p>
                      <a:pPr algn="l" rtl="0" fontAlgn="ctr"/>
                      <a:endParaRPr lang="en-US" sz="1300" b="1" u="none" strike="noStrike" dirty="0">
                        <a:effectLst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AUC </a:t>
                      </a:r>
                    </a:p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(CI)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Over- optimism estimate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Adjusted AUC (CI)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Sens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Spec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NPV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PPV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b="1" u="none" strike="noStrike" dirty="0">
                          <a:effectLst/>
                        </a:rPr>
                        <a:t>Accuracy</a:t>
                      </a:r>
                      <a:endParaRPr lang="en-US" sz="13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5050">
                        <a:alpha val="10196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9846405"/>
                  </a:ext>
                </a:extLst>
              </a:tr>
              <a:tr h="30156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500" b="1" u="none" strike="noStrike" dirty="0">
                          <a:solidFill>
                            <a:srgbClr val="7030A0"/>
                          </a:solidFill>
                          <a:effectLst/>
                        </a:rPr>
                        <a:t>3 EV- miRNA QC Cq model</a:t>
                      </a:r>
                      <a:endParaRPr lang="en-US" sz="1500" b="1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836 </a:t>
                      </a:r>
                    </a:p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(0.750-0.922)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000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836 (0.750-0.922)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919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642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938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576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solidFill>
                            <a:srgbClr val="7030A0"/>
                          </a:solidFill>
                          <a:effectLst/>
                        </a:rPr>
                        <a:t>0.738</a:t>
                      </a:r>
                      <a:endParaRPr lang="en-US" sz="1100" b="0" i="0" u="none" strike="noStrike" dirty="0">
                        <a:solidFill>
                          <a:srgbClr val="7030A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6928307"/>
                  </a:ext>
                </a:extLst>
              </a:tr>
            </a:tbl>
          </a:graphicData>
        </a:graphic>
      </p:graphicFrame>
      <p:sp>
        <p:nvSpPr>
          <p:cNvPr id="2" name="Tekstvak 1">
            <a:extLst>
              <a:ext uri="{FF2B5EF4-FFF2-40B4-BE49-F238E27FC236}">
                <a16:creationId xmlns:a16="http://schemas.microsoft.com/office/drawing/2014/main" id="{445269A6-FBAD-70F0-C073-4F3358FDAF49}"/>
              </a:ext>
            </a:extLst>
          </p:cNvPr>
          <p:cNvSpPr txBox="1"/>
          <p:nvPr/>
        </p:nvSpPr>
        <p:spPr>
          <a:xfrm>
            <a:off x="188503" y="793504"/>
            <a:ext cx="362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A</a:t>
            </a:r>
          </a:p>
        </p:txBody>
      </p:sp>
      <p:pic>
        <p:nvPicPr>
          <p:cNvPr id="26" name="Afbeelding 25">
            <a:extLst>
              <a:ext uri="{FF2B5EF4-FFF2-40B4-BE49-F238E27FC236}">
                <a16:creationId xmlns:a16="http://schemas.microsoft.com/office/drawing/2014/main" id="{6159E8E2-70A9-6F50-CA55-0E00EFF0CF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72001" y="842634"/>
            <a:ext cx="3292706" cy="3467274"/>
          </a:xfrm>
          <a:prstGeom prst="rect">
            <a:avLst/>
          </a:prstGeom>
        </p:spPr>
      </p:pic>
      <p:sp>
        <p:nvSpPr>
          <p:cNvPr id="3" name="Tekstvak 2">
            <a:extLst>
              <a:ext uri="{FF2B5EF4-FFF2-40B4-BE49-F238E27FC236}">
                <a16:creationId xmlns:a16="http://schemas.microsoft.com/office/drawing/2014/main" id="{B707A6E6-D4BF-8E77-A8F0-C131481882AA}"/>
              </a:ext>
            </a:extLst>
          </p:cNvPr>
          <p:cNvSpPr txBox="1"/>
          <p:nvPr/>
        </p:nvSpPr>
        <p:spPr>
          <a:xfrm>
            <a:off x="188503" y="4194000"/>
            <a:ext cx="362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B</a:t>
            </a:r>
          </a:p>
        </p:txBody>
      </p:sp>
      <p:sp>
        <p:nvSpPr>
          <p:cNvPr id="5" name="Tekstvak 4">
            <a:extLst>
              <a:ext uri="{FF2B5EF4-FFF2-40B4-BE49-F238E27FC236}">
                <a16:creationId xmlns:a16="http://schemas.microsoft.com/office/drawing/2014/main" id="{3140EBB7-3A74-BF9C-1A46-44E488D4B98D}"/>
              </a:ext>
            </a:extLst>
          </p:cNvPr>
          <p:cNvSpPr txBox="1"/>
          <p:nvPr/>
        </p:nvSpPr>
        <p:spPr>
          <a:xfrm>
            <a:off x="4510524" y="786878"/>
            <a:ext cx="3624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b="1" dirty="0"/>
              <a:t>C</a:t>
            </a:r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D7F7E90B-FFB3-2D9F-ABB5-CA14A45AD08B}"/>
              </a:ext>
            </a:extLst>
          </p:cNvPr>
          <p:cNvSpPr txBox="1"/>
          <p:nvPr/>
        </p:nvSpPr>
        <p:spPr>
          <a:xfrm>
            <a:off x="6525261" y="3613780"/>
            <a:ext cx="1140977" cy="200055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700" b="0" i="0" u="none" strike="noStrike" baseline="0" dirty="0">
                <a:latin typeface="Arial" panose="020B0604020202020204" pitchFamily="34" charset="0"/>
              </a:rPr>
              <a:t>3−miRNA Q</a:t>
            </a:r>
            <a:r>
              <a:rPr lang="en-US" sz="700" b="0" i="0" u="none" strike="noStrike" baseline="0" dirty="0">
                <a:latin typeface="ArialMT"/>
              </a:rPr>
              <a:t>C Cq </a:t>
            </a:r>
            <a:r>
              <a:rPr lang="en-US" sz="700" b="0" i="0" u="none" strike="noStrike" baseline="0" dirty="0">
                <a:latin typeface="Arial" panose="020B0604020202020204" pitchFamily="34" charset="0"/>
              </a:rPr>
              <a:t>Model</a:t>
            </a:r>
            <a:endParaRPr lang="en-US" sz="700" dirty="0"/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65636BE-5E0A-3FCA-0C89-71D481882D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13306873"/>
              </p:ext>
            </p:extLst>
          </p:nvPr>
        </p:nvGraphicFramePr>
        <p:xfrm>
          <a:off x="436563" y="935038"/>
          <a:ext cx="4022725" cy="3119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800872" imgH="2945700" progId="Prism9.Document">
                  <p:embed/>
                </p:oleObj>
              </mc:Choice>
              <mc:Fallback>
                <p:oleObj name="Prism 9" r:id="rId3" imgW="3800872" imgH="2945700" progId="Prism9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F87149E7-D459-07CA-3303-C12642C9B6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6563" y="935038"/>
                        <a:ext cx="4022725" cy="3119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1" name="Rechte verbindingslijn 10">
            <a:extLst>
              <a:ext uri="{FF2B5EF4-FFF2-40B4-BE49-F238E27FC236}">
                <a16:creationId xmlns:a16="http://schemas.microsoft.com/office/drawing/2014/main" id="{81E41B67-80FA-F713-764C-D6B784234112}"/>
              </a:ext>
            </a:extLst>
          </p:cNvPr>
          <p:cNvCxnSpPr>
            <a:cxnSpLocks/>
          </p:cNvCxnSpPr>
          <p:nvPr/>
        </p:nvCxnSpPr>
        <p:spPr>
          <a:xfrm>
            <a:off x="7622697" y="3503851"/>
            <a:ext cx="0" cy="326168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8593886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313</TotalTime>
  <Words>61</Words>
  <Application>Microsoft Office PowerPoint</Application>
  <PresentationFormat>Diavoorstelling (4:3)</PresentationFormat>
  <Paragraphs>24</Paragraphs>
  <Slides>1</Slides>
  <Notes>0</Notes>
  <HiddenSlides>0</HiddenSlides>
  <MMClips>0</MMClips>
  <ScaleCrop>false</ScaleCrop>
  <HeadingPairs>
    <vt:vector size="8" baseType="variant">
      <vt:variant>
        <vt:lpstr>Gebruikte lettertypen</vt:lpstr>
      </vt:variant>
      <vt:variant>
        <vt:i4>4</vt:i4>
      </vt:variant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7" baseType="lpstr">
      <vt:lpstr>Arial</vt:lpstr>
      <vt:lpstr>ArialMT</vt:lpstr>
      <vt:lpstr>Calibri</vt:lpstr>
      <vt:lpstr>Calibri Light</vt:lpstr>
      <vt:lpstr>Kantoorthema</vt:lpstr>
      <vt:lpstr>Prism 9</vt:lpstr>
      <vt:lpstr>PowerPoint-presentatie</vt:lpstr>
    </vt:vector>
  </TitlesOfParts>
  <Company>V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MS analyses</dc:title>
  <dc:creator>Drees, E.E.E. (Esther)</dc:creator>
  <cp:lastModifiedBy>Esther Drees</cp:lastModifiedBy>
  <cp:revision>816</cp:revision>
  <dcterms:created xsi:type="dcterms:W3CDTF">2020-10-20T10:37:57Z</dcterms:created>
  <dcterms:modified xsi:type="dcterms:W3CDTF">2024-06-07T07:02:37Z</dcterms:modified>
</cp:coreProperties>
</file>